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60" r:id="rId4"/>
    <p:sldId id="257" r:id="rId5"/>
    <p:sldId id="264" r:id="rId6"/>
    <p:sldId id="258" r:id="rId7"/>
    <p:sldId id="261" r:id="rId8"/>
    <p:sldId id="262" r:id="rId9"/>
    <p:sldId id="263" r:id="rId10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dmin" initials="Ad" lastIdx="2" clrIdx="0">
    <p:extLst>
      <p:ext uri="{19B8F6BF-5375-455C-9EA6-DF929625EA0E}">
        <p15:presenceInfo xmlns:p15="http://schemas.microsoft.com/office/powerpoint/2012/main" userId="Admi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DACC-9208-405E-8737-5910D15A733C}" type="datetimeFigureOut">
              <a:rPr lang="it-IT" smtClean="0"/>
              <a:t>26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863E5-86A4-47EF-B942-1B33FA4A601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391279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DACC-9208-405E-8737-5910D15A733C}" type="datetimeFigureOut">
              <a:rPr lang="it-IT" smtClean="0"/>
              <a:t>26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863E5-86A4-47EF-B942-1B33FA4A601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56572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DACC-9208-405E-8737-5910D15A733C}" type="datetimeFigureOut">
              <a:rPr lang="it-IT" smtClean="0"/>
              <a:t>26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863E5-86A4-47EF-B942-1B33FA4A601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579992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DACC-9208-405E-8737-5910D15A733C}" type="datetimeFigureOut">
              <a:rPr lang="it-IT" smtClean="0"/>
              <a:t>26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863E5-86A4-47EF-B942-1B33FA4A601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705637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DACC-9208-405E-8737-5910D15A733C}" type="datetimeFigureOut">
              <a:rPr lang="it-IT" smtClean="0"/>
              <a:t>26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863E5-86A4-47EF-B942-1B33FA4A601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254956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DACC-9208-405E-8737-5910D15A733C}" type="datetimeFigureOut">
              <a:rPr lang="it-IT" smtClean="0"/>
              <a:t>26/01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863E5-86A4-47EF-B942-1B33FA4A601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062053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DACC-9208-405E-8737-5910D15A733C}" type="datetimeFigureOut">
              <a:rPr lang="it-IT" smtClean="0"/>
              <a:t>26/01/20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863E5-86A4-47EF-B942-1B33FA4A601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115547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DACC-9208-405E-8737-5910D15A733C}" type="datetimeFigureOut">
              <a:rPr lang="it-IT" smtClean="0"/>
              <a:t>26/01/20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863E5-86A4-47EF-B942-1B33FA4A601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405777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DACC-9208-405E-8737-5910D15A733C}" type="datetimeFigureOut">
              <a:rPr lang="it-IT" smtClean="0"/>
              <a:t>26/01/20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863E5-86A4-47EF-B942-1B33FA4A601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415094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DACC-9208-405E-8737-5910D15A733C}" type="datetimeFigureOut">
              <a:rPr lang="it-IT" smtClean="0"/>
              <a:t>26/01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863E5-86A4-47EF-B942-1B33FA4A601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74421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DACC-9208-405E-8737-5910D15A733C}" type="datetimeFigureOut">
              <a:rPr lang="it-IT" smtClean="0"/>
              <a:t>26/01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863E5-86A4-47EF-B942-1B33FA4A601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8891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61DACC-9208-405E-8737-5910D15A733C}" type="datetimeFigureOut">
              <a:rPr lang="it-IT" smtClean="0"/>
              <a:t>26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7863E5-86A4-47EF-B942-1B33FA4A601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52071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001487" y="1030908"/>
            <a:ext cx="10014856" cy="35496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terspecific and intraspecific phenotypic diversity for drought adaptation in bioenergy </a:t>
            </a:r>
            <a:r>
              <a:rPr lang="en-US" b="1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rundo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pecies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unning title: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henotyping </a:t>
            </a:r>
            <a:r>
              <a:rPr lang="en-US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rundo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or stress tolerance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it-IT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chele </a:t>
            </a:r>
            <a:r>
              <a:rPr lang="it-IT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aralli</a:t>
            </a:r>
            <a:r>
              <a:rPr lang="it-IT" baseline="300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it-IT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it-IT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evin Williams</a:t>
            </a:r>
            <a:r>
              <a:rPr lang="it-IT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it-IT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Fiona Corke</a:t>
            </a:r>
            <a:r>
              <a:rPr lang="it-IT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it-IT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it-IT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ngai</a:t>
            </a:r>
            <a:r>
              <a:rPr lang="it-IT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Li</a:t>
            </a:r>
            <a:r>
              <a:rPr lang="it-IT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it-IT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John H. Doonan</a:t>
            </a:r>
            <a:r>
              <a:rPr lang="it-IT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it-IT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Claudio </a:t>
            </a:r>
            <a:r>
              <a:rPr lang="it-IT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arotto</a:t>
            </a:r>
            <a:r>
              <a:rPr lang="it-IT" baseline="300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Biodiversity and Molecular Ecology, Research and Innovation Centre, Fondazione Edmund Mach, via Mach 1, 38010, San Michele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ll’Adige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TN), Italy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baseline="30000" dirty="0">
                <a:latin typeface="Arial" panose="020B0604020202020204" pitchFamily="34" charset="0"/>
                <a:ea typeface="Calibri" panose="020F0502020204030204" pitchFamily="34" charset="0"/>
              </a:rPr>
              <a:t>2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</a:rPr>
              <a:t>National Plant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</a:rPr>
              <a:t>Phenomics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</a:rPr>
              <a:t> Centre (NPPC), IBERS,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</a:rPr>
              <a:t>Plas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</a:rPr>
              <a:t>Gogerddan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</a:rPr>
              <a:t>,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</a:rPr>
              <a:t>Aberystwyth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</a:rPr>
              <a:t> University, Wales, UK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38151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279115876"/>
              </p:ext>
            </p:extLst>
          </p:nvPr>
        </p:nvGraphicFramePr>
        <p:xfrm>
          <a:off x="2591846" y="995331"/>
          <a:ext cx="5918200" cy="215875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320800">
                  <a:extLst>
                    <a:ext uri="{9D8B030D-6E8A-4147-A177-3AD203B41FA5}">
                      <a16:colId xmlns:a16="http://schemas.microsoft.com/office/drawing/2014/main" val="3478473040"/>
                    </a:ext>
                  </a:extLst>
                </a:gridCol>
                <a:gridCol w="1638300">
                  <a:extLst>
                    <a:ext uri="{9D8B030D-6E8A-4147-A177-3AD203B41FA5}">
                      <a16:colId xmlns:a16="http://schemas.microsoft.com/office/drawing/2014/main" val="390495557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2603563093"/>
                    </a:ext>
                  </a:extLst>
                </a:gridCol>
                <a:gridCol w="558800">
                  <a:extLst>
                    <a:ext uri="{9D8B030D-6E8A-4147-A177-3AD203B41FA5}">
                      <a16:colId xmlns:a16="http://schemas.microsoft.com/office/drawing/2014/main" val="304303650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4232769509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2869342776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pecies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ccession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ountry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Latitude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Longitude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ampling date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extLst>
                  <a:ext uri="{0D108BD9-81ED-4DB2-BD59-A6C34878D82A}">
                    <a16:rowId xmlns:a16="http://schemas.microsoft.com/office/drawing/2014/main" val="2192504703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Arundo donax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Bologna (Castel Maggiore)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Italy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44°37′49’’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11°18′30’’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29/10/2019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extLst>
                  <a:ext uri="{0D108BD9-81ED-4DB2-BD59-A6C34878D82A}">
                    <a16:rowId xmlns:a16="http://schemas.microsoft.com/office/drawing/2014/main" val="3128420271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effectLst/>
                        </a:rPr>
                        <a:t>Arundo donax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Finale Ligure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Italy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44°10′39’’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8°22′12’’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28/10/2019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extLst>
                  <a:ext uri="{0D108BD9-81ED-4DB2-BD59-A6C34878D82A}">
                    <a16:rowId xmlns:a16="http://schemas.microsoft.com/office/drawing/2014/main" val="3072680068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effectLst/>
                        </a:rPr>
                        <a:t>Arundo donax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effectLst/>
                        </a:rPr>
                        <a:t>Torviscosa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Italy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45°46'37"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13°16'41"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06/11/2019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extLst>
                  <a:ext uri="{0D108BD9-81ED-4DB2-BD59-A6C34878D82A}">
                    <a16:rowId xmlns:a16="http://schemas.microsoft.com/office/drawing/2014/main" val="2013184663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Arundo dona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effectLst/>
                        </a:rPr>
                        <a:t>Bersezio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Croati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45°11'48''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14°14'26''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06/11/2019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extLst>
                  <a:ext uri="{0D108BD9-81ED-4DB2-BD59-A6C34878D82A}">
                    <a16:rowId xmlns:a16="http://schemas.microsoft.com/office/drawing/2014/main" val="1884072604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Arundo dona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effectLst/>
                        </a:rPr>
                        <a:t>Zambana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Italy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46°09'39''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11°04'43''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14/11/2019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extLst>
                  <a:ext uri="{0D108BD9-81ED-4DB2-BD59-A6C34878D82A}">
                    <a16:rowId xmlns:a16="http://schemas.microsoft.com/office/drawing/2014/main" val="1616346901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Arundo dona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effectLst/>
                        </a:rPr>
                        <a:t>Sesto Fiorentino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Italy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43°49'07''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11°10'38''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31/10/2019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extLst>
                  <a:ext uri="{0D108BD9-81ED-4DB2-BD59-A6C34878D82A}">
                    <a16:rowId xmlns:a16="http://schemas.microsoft.com/office/drawing/2014/main" val="3380781645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Arundo donaciformis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effectLst/>
                        </a:rPr>
                        <a:t>Marina di Andora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Italy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43°57′49’’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8°10′00’’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28/10/2019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extLst>
                  <a:ext uri="{0D108BD9-81ED-4DB2-BD59-A6C34878D82A}">
                    <a16:rowId xmlns:a16="http://schemas.microsoft.com/office/drawing/2014/main" val="3674313849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Arundo donaciformis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effectLst/>
                        </a:rPr>
                        <a:t>Finale Ligure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Italy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44°10′39’’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8°22′12’’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28/10/2019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extLst>
                  <a:ext uri="{0D108BD9-81ED-4DB2-BD59-A6C34878D82A}">
                    <a16:rowId xmlns:a16="http://schemas.microsoft.com/office/drawing/2014/main" val="2786750958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Arundo donaciformis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effectLst/>
                        </a:rPr>
                        <a:t>Punta Cervo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 err="1">
                          <a:effectLst/>
                        </a:rPr>
                        <a:t>Italy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43°55′38’’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8°07′37’’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28/10/2019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extLst>
                  <a:ext uri="{0D108BD9-81ED-4DB2-BD59-A6C34878D82A}">
                    <a16:rowId xmlns:a16="http://schemas.microsoft.com/office/drawing/2014/main" val="1064538421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Arundo plinii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effectLst/>
                        </a:rPr>
                        <a:t>Bologna (Castel Maggiore)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Italy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44°37′49’’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11°18′30’’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29/10/2019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extLst>
                  <a:ext uri="{0D108BD9-81ED-4DB2-BD59-A6C34878D82A}">
                    <a16:rowId xmlns:a16="http://schemas.microsoft.com/office/drawing/2014/main" val="1739396568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Arundo plinii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effectLst/>
                        </a:rPr>
                        <a:t>Argelato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Italy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44°37′49’’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11°18′30’’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29/10/2019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extLst>
                  <a:ext uri="{0D108BD9-81ED-4DB2-BD59-A6C34878D82A}">
                    <a16:rowId xmlns:a16="http://schemas.microsoft.com/office/drawing/2014/main" val="197418216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Arundo plinii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effectLst/>
                        </a:rPr>
                        <a:t>Sasso Marconi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Italy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44°22′20’’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11°15′10’’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effectLst/>
                        </a:rPr>
                        <a:t>29/10/2019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extLst>
                  <a:ext uri="{0D108BD9-81ED-4DB2-BD59-A6C34878D82A}">
                    <a16:rowId xmlns:a16="http://schemas.microsoft.com/office/drawing/2014/main" val="1138636144"/>
                  </a:ext>
                </a:extLst>
              </a:tr>
            </a:tbl>
          </a:graphicData>
        </a:graphic>
      </p:graphicFrame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2591846" y="599505"/>
            <a:ext cx="5915402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it-IT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le 1</a:t>
            </a:r>
            <a:r>
              <a:rPr kumimoji="0" lang="en-US" altLang="it-IT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Species, accession and source country, location and sampling date. </a:t>
            </a:r>
            <a:endParaRPr kumimoji="0" lang="it-IT" altLang="it-IT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it-IT" altLang="it-IT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94847" y="3549909"/>
            <a:ext cx="4729953" cy="22967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85668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2591846" y="599505"/>
            <a:ext cx="5270995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it-IT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le 2</a:t>
            </a:r>
            <a:r>
              <a:rPr lang="en-US" altLang="it-IT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altLang="it-IT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an precipitation and temperature for each sampling site</a:t>
            </a:r>
            <a:endParaRPr kumimoji="0" lang="it-IT" altLang="it-IT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it-IT" altLang="it-IT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4305301"/>
              </p:ext>
            </p:extLst>
          </p:nvPr>
        </p:nvGraphicFramePr>
        <p:xfrm>
          <a:off x="1644707" y="1771287"/>
          <a:ext cx="7073900" cy="236982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44600">
                  <a:extLst>
                    <a:ext uri="{9D8B030D-6E8A-4147-A177-3AD203B41FA5}">
                      <a16:colId xmlns:a16="http://schemas.microsoft.com/office/drawing/2014/main" val="2948162666"/>
                    </a:ext>
                  </a:extLst>
                </a:gridCol>
                <a:gridCol w="1549400">
                  <a:extLst>
                    <a:ext uri="{9D8B030D-6E8A-4147-A177-3AD203B41FA5}">
                      <a16:colId xmlns:a16="http://schemas.microsoft.com/office/drawing/2014/main" val="873933232"/>
                    </a:ext>
                  </a:extLst>
                </a:gridCol>
                <a:gridCol w="2108200">
                  <a:extLst>
                    <a:ext uri="{9D8B030D-6E8A-4147-A177-3AD203B41FA5}">
                      <a16:colId xmlns:a16="http://schemas.microsoft.com/office/drawing/2014/main" val="1729309436"/>
                    </a:ext>
                  </a:extLst>
                </a:gridCol>
                <a:gridCol w="2171700">
                  <a:extLst>
                    <a:ext uri="{9D8B030D-6E8A-4147-A177-3AD203B41FA5}">
                      <a16:colId xmlns:a16="http://schemas.microsoft.com/office/drawing/2014/main" val="531838215"/>
                    </a:ext>
                  </a:extLst>
                </a:gridCol>
              </a:tblGrid>
              <a:tr h="170724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b="1" u="none" strike="noStrike" dirty="0" err="1">
                          <a:effectLst/>
                        </a:rPr>
                        <a:t>Species</a:t>
                      </a:r>
                      <a:endParaRPr lang="it-I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b="1" u="none" strike="noStrike" dirty="0" err="1">
                          <a:effectLst/>
                        </a:rPr>
                        <a:t>Accession</a:t>
                      </a:r>
                      <a:endParaRPr lang="it-I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b="1" u="none" strike="noStrike" dirty="0" err="1">
                          <a:effectLst/>
                        </a:rPr>
                        <a:t>Mean</a:t>
                      </a:r>
                      <a:r>
                        <a:rPr lang="it-IT" sz="1100" b="1" u="none" strike="noStrike" dirty="0">
                          <a:effectLst/>
                        </a:rPr>
                        <a:t> temperature (°C, 2007-2016)</a:t>
                      </a:r>
                      <a:endParaRPr lang="it-I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b="1" u="none" strike="noStrike" dirty="0" err="1">
                          <a:effectLst/>
                        </a:rPr>
                        <a:t>Mean</a:t>
                      </a:r>
                      <a:r>
                        <a:rPr lang="it-IT" sz="1100" b="1" u="none" strike="noStrike" dirty="0">
                          <a:effectLst/>
                        </a:rPr>
                        <a:t> </a:t>
                      </a:r>
                      <a:r>
                        <a:rPr lang="it-IT" sz="1100" b="1" u="none" strike="noStrike" dirty="0" err="1">
                          <a:effectLst/>
                        </a:rPr>
                        <a:t>precipiation</a:t>
                      </a:r>
                      <a:r>
                        <a:rPr lang="it-IT" sz="1100" b="1" u="none" strike="noStrike" dirty="0">
                          <a:effectLst/>
                        </a:rPr>
                        <a:t> (mm, 2007-2016)</a:t>
                      </a:r>
                      <a:endParaRPr lang="it-I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94978325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Arundo donax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Bologna (Castel Maggiore)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 dirty="0">
                          <a:effectLst/>
                        </a:rPr>
                        <a:t>15.3</a:t>
                      </a:r>
                      <a:endParaRPr lang="it-I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>
                          <a:effectLst/>
                        </a:rPr>
                        <a:t>771.4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71345451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Arundo donax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Finale Ligure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 dirty="0">
                          <a:effectLst/>
                        </a:rPr>
                        <a:t>16.6</a:t>
                      </a:r>
                      <a:endParaRPr lang="it-I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>
                          <a:effectLst/>
                        </a:rPr>
                        <a:t>950.0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54078710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Arundo donax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Torviscosa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 dirty="0">
                          <a:effectLst/>
                        </a:rPr>
                        <a:t>14.5</a:t>
                      </a:r>
                      <a:endParaRPr lang="it-I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>
                          <a:effectLst/>
                        </a:rPr>
                        <a:t>1409.7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90378486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Arundo donax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Bersezio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>
                          <a:effectLst/>
                        </a:rPr>
                        <a:t>16.1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 dirty="0">
                          <a:effectLst/>
                        </a:rPr>
                        <a:t>926.8</a:t>
                      </a:r>
                      <a:endParaRPr lang="it-I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381583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Arundo donax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Zambana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>
                          <a:effectLst/>
                        </a:rPr>
                        <a:t>13.3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 dirty="0">
                          <a:effectLst/>
                        </a:rPr>
                        <a:t>1064.0</a:t>
                      </a:r>
                      <a:endParaRPr lang="it-I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43535105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Arundo donax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Sesto Fiorentino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>
                          <a:effectLst/>
                        </a:rPr>
                        <a:t>16.3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 dirty="0">
                          <a:effectLst/>
                        </a:rPr>
                        <a:t>788.7</a:t>
                      </a:r>
                      <a:endParaRPr lang="it-I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67077264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Arundo donaciformis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Marina di Andora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>
                          <a:effectLst/>
                        </a:rPr>
                        <a:t>16.6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 dirty="0">
                          <a:effectLst/>
                        </a:rPr>
                        <a:t>713.1</a:t>
                      </a:r>
                      <a:endParaRPr lang="it-I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88293529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Arundo donaciformis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Finale Ligure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>
                          <a:effectLst/>
                        </a:rPr>
                        <a:t>16.6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 dirty="0">
                          <a:effectLst/>
                        </a:rPr>
                        <a:t>950.0</a:t>
                      </a:r>
                      <a:endParaRPr lang="it-I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42393999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Arundo donaciformis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Punta Cervo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>
                          <a:effectLst/>
                        </a:rPr>
                        <a:t>16.6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 dirty="0">
                          <a:effectLst/>
                        </a:rPr>
                        <a:t>713.1</a:t>
                      </a:r>
                      <a:endParaRPr lang="it-I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4089856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Arundo plinii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Bologna (Castel Maggiore)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>
                          <a:effectLst/>
                        </a:rPr>
                        <a:t>15.3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>
                          <a:effectLst/>
                        </a:rPr>
                        <a:t>771.4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89192798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Arundo plinii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Argelato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>
                          <a:effectLst/>
                        </a:rPr>
                        <a:t>15.3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 dirty="0">
                          <a:effectLst/>
                        </a:rPr>
                        <a:t>771.4</a:t>
                      </a:r>
                      <a:endParaRPr lang="it-I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1009697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Arundo plinii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Sasso Marconi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>
                          <a:effectLst/>
                        </a:rPr>
                        <a:t>15.3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100" u="none" strike="noStrike" dirty="0">
                          <a:effectLst/>
                        </a:rPr>
                        <a:t>771.4</a:t>
                      </a:r>
                      <a:endParaRPr lang="it-I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48176053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357232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upplementary 3</a:t>
            </a:r>
            <a:endParaRPr lang="it-IT" dirty="0"/>
          </a:p>
        </p:txBody>
      </p:sp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it-IT"/>
          </a:p>
        </p:txBody>
      </p:sp>
      <p:pic>
        <p:nvPicPr>
          <p:cNvPr id="1028" name="Picture 6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80119" y="1690688"/>
            <a:ext cx="3116263" cy="22701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ctangle 6"/>
          <p:cNvSpPr>
            <a:spLocks noChangeArrowheads="1"/>
          </p:cNvSpPr>
          <p:nvPr/>
        </p:nvSpPr>
        <p:spPr bwMode="auto">
          <a:xfrm rot="10800000" flipV="1">
            <a:off x="1735015" y="3827650"/>
            <a:ext cx="5814646" cy="7694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it-IT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le 3</a:t>
            </a:r>
            <a:r>
              <a:rPr kumimoji="0" lang="en-US" altLang="it-IT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Example of daily VPD cycles. The system was able to successfully maintain VPD at the thresholds chosen. Before each VPD cycle, plants were subjected to a 30 min acclimation period. Plants were acclimated to the growth chamber for a period of 1-2h before the increasing in VPD levels.</a:t>
            </a:r>
            <a:endParaRPr kumimoji="0" lang="en-US" altLang="it-IT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80755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upplementary 4</a:t>
            </a:r>
            <a:endParaRPr lang="it-IT" dirty="0"/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4401671" y="152400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it-IT"/>
          </a:p>
        </p:txBody>
      </p:sp>
      <p:pic>
        <p:nvPicPr>
          <p:cNvPr id="1025" name="Picture 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91393" y="1981200"/>
            <a:ext cx="3589338" cy="35169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3890683" y="5621471"/>
            <a:ext cx="3290048" cy="11079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it-IT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le 4.</a:t>
            </a:r>
            <a:r>
              <a:rPr kumimoji="0" lang="en-US" altLang="it-IT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nvironmental conditions inside the NPPC greenhouse during the experiment. A) Average daily temperature (°C) and </a:t>
            </a:r>
            <a:r>
              <a:rPr kumimoji="0" lang="en-US" altLang="it-IT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hotosynthetically</a:t>
            </a:r>
            <a:r>
              <a:rPr kumimoji="0" lang="en-US" altLang="it-IT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ctive radiation inside the greenhouse (PAR). B) Average daily relative humidity and daily vapour pressure deficit (VPD)</a:t>
            </a:r>
            <a:endParaRPr kumimoji="0" lang="en-US" altLang="it-IT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14253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/>
          <a:lstStyle/>
          <a:p>
            <a:r>
              <a:rPr lang="en-US" dirty="0" smtClean="0"/>
              <a:t>Supplementary 5</a:t>
            </a:r>
            <a:endParaRPr lang="it-IT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2867" y="1934528"/>
            <a:ext cx="7504414" cy="2885194"/>
          </a:xfrm>
          <a:prstGeom prst="rect">
            <a:avLst/>
          </a:prstGeom>
        </p:spPr>
      </p:pic>
      <p:sp>
        <p:nvSpPr>
          <p:cNvPr id="6" name="Rectangle 5"/>
          <p:cNvSpPr>
            <a:spLocks noChangeArrowheads="1"/>
          </p:cNvSpPr>
          <p:nvPr/>
        </p:nvSpPr>
        <p:spPr bwMode="auto">
          <a:xfrm rot="10800000" flipV="1">
            <a:off x="1743723" y="5063562"/>
            <a:ext cx="5814646" cy="43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it-IT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le 5</a:t>
            </a:r>
            <a:r>
              <a:rPr kumimoji="0" lang="en-US" altLang="it-IT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FTSW during the experimental period (including recovery) for A. donaciformis, A. donax and A. plinii. Points</a:t>
            </a:r>
            <a:r>
              <a:rPr kumimoji="0" lang="en-US" altLang="it-IT" sz="11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epresent measured values for each pot.</a:t>
            </a:r>
            <a:r>
              <a:rPr kumimoji="0" lang="en-US" altLang="it-IT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kumimoji="0" lang="en-US" altLang="it-IT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67617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upplementary 6</a:t>
            </a:r>
            <a:endParaRPr lang="it-IT" dirty="0"/>
          </a:p>
        </p:txBody>
      </p:sp>
      <p:pic>
        <p:nvPicPr>
          <p:cNvPr id="4" name="Content Placeholder 3"/>
          <p:cNvPicPr>
            <a:picLocks noGrp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8240" y="1845284"/>
            <a:ext cx="8547709" cy="2526418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062445" y="4151735"/>
            <a:ext cx="8395063" cy="13721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it-IT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  <a:spcAft>
                <a:spcPts val="800"/>
              </a:spcAft>
            </a:pPr>
            <a:r>
              <a:rPr lang="en-US" sz="1100" b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le 6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ample of CO</a:t>
            </a:r>
            <a:r>
              <a:rPr lang="en-US" sz="1100" baseline="-25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ssimilation rate (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to sub-stomatal CO</a:t>
            </a:r>
            <a:r>
              <a:rPr lang="en-US" sz="1100" baseline="-25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oncentration (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100" i="1" baseline="-25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US" sz="1100" baseline="-25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urves with relative curve-fitting for 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 donaciformis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, 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 donax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B) and 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 plinii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C).  Symbols are measurements, the black line the fitted model of photosynthesis. Colored lines indicate the two photosynthesis rates of the model (Ac and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j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endParaRPr lang="it-IT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134379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upplementary 7</a:t>
            </a:r>
            <a:endParaRPr lang="it-IT" dirty="0"/>
          </a:p>
        </p:txBody>
      </p:sp>
      <p:sp>
        <p:nvSpPr>
          <p:cNvPr id="5" name="Rectangle 4"/>
          <p:cNvSpPr/>
          <p:nvPr/>
        </p:nvSpPr>
        <p:spPr>
          <a:xfrm>
            <a:off x="2046514" y="4720044"/>
            <a:ext cx="6096000" cy="572849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>
              <a:lnSpc>
                <a:spcPct val="150000"/>
              </a:lnSpc>
              <a:spcAft>
                <a:spcPts val="800"/>
              </a:spcAft>
            </a:pPr>
            <a:r>
              <a:rPr lang="en-US" sz="1100" b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le 7. 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ample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f normalized stomatal conductance (</a:t>
            </a:r>
            <a:r>
              <a:rPr lang="en-US" sz="11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US" sz="1100" i="1" baseline="-25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following a low-to-high light transition. 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 donaciformis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ed quick </a:t>
            </a:r>
            <a:r>
              <a:rPr lang="en-US" sz="11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US" sz="1100" i="1" baseline="-25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duction, while 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 plinii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as much slower.</a:t>
            </a:r>
            <a:endParaRPr lang="it-IT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9858" y="2177923"/>
            <a:ext cx="9732283" cy="20548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040541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upplementary 8</a:t>
            </a:r>
            <a:endParaRPr lang="it-IT" dirty="0"/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2142564" y="1690688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it-IT"/>
          </a:p>
        </p:txBody>
      </p:sp>
      <p:pic>
        <p:nvPicPr>
          <p:cNvPr id="1025" name="Picture 7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2564" y="1390650"/>
            <a:ext cx="6647328" cy="41529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2056839" y="5757725"/>
            <a:ext cx="6293224" cy="6001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it-IT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le 8. </a:t>
            </a:r>
            <a:r>
              <a:rPr kumimoji="0" lang="en-US" altLang="it-IT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covery of daytime and nighttime WU after 6 days of recovery from water stress and expressed as % compared to average WU of WW plants. Data are shown for all the species and accession (n=3-9) and ANOVA output is shown in the figure.</a:t>
            </a:r>
            <a:endParaRPr kumimoji="0" lang="en-US" altLang="it-IT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89880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5</TotalTime>
  <Words>641</Words>
  <Application>Microsoft Office PowerPoint</Application>
  <PresentationFormat>Widescreen</PresentationFormat>
  <Paragraphs>150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Supplementary 3</vt:lpstr>
      <vt:lpstr>Supplementary 4</vt:lpstr>
      <vt:lpstr>Supplementary 5</vt:lpstr>
      <vt:lpstr>Supplementary 6</vt:lpstr>
      <vt:lpstr>Supplementary 7</vt:lpstr>
      <vt:lpstr>Supplementary 8</vt:lpstr>
    </vt:vector>
  </TitlesOfParts>
  <Company>FE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tente Windows</dc:creator>
  <cp:lastModifiedBy>Admin</cp:lastModifiedBy>
  <cp:revision>23</cp:revision>
  <dcterms:created xsi:type="dcterms:W3CDTF">2020-09-10T12:59:59Z</dcterms:created>
  <dcterms:modified xsi:type="dcterms:W3CDTF">2021-01-26T15:22:42Z</dcterms:modified>
</cp:coreProperties>
</file>